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iXrvtHb5SWpEKsK9+OFPa/51KG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9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Google Shape;174;p20">
            <a:extLst>
              <a:ext uri="{FF2B5EF4-FFF2-40B4-BE49-F238E27FC236}">
                <a16:creationId xmlns:a16="http://schemas.microsoft.com/office/drawing/2014/main" id="{FC0717F2-AC88-49D0-8013-225CE043CECB}"/>
              </a:ext>
            </a:extLst>
          </p:cNvPr>
          <p:cNvSpPr txBox="1"/>
          <p:nvPr/>
        </p:nvSpPr>
        <p:spPr>
          <a:xfrm>
            <a:off x="384538" y="7808464"/>
            <a:ext cx="6088924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</a:t>
            </a: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4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</a:t>
            </a:r>
            <a:r>
              <a:rPr lang="en-US" sz="1200" dirty="0">
                <a:solidFill>
                  <a:schemeClr val="dk1"/>
                </a:solidFill>
              </a:rPr>
              <a:t>from heterologously expressed 6xHIS TaAMY1 peptides with  wheat TaAMY1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Peptides are shown in alternating colors (black/red) and those with the same amino acid sequences are stacked to show the number of times a peptide sequence was recovered from peptide sequencing analysis. In total </a:t>
            </a:r>
            <a:r>
              <a:rPr lang="en-US" sz="1200" dirty="0"/>
              <a:t>14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unique peptides were recovered with 56%  total coverage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E505656-9373-4CF1-8A4E-151028FD94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9948" y="547499"/>
            <a:ext cx="5438103" cy="72609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5614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7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MDPI</cp:lastModifiedBy>
  <cp:revision>22</cp:revision>
  <dcterms:created xsi:type="dcterms:W3CDTF">2021-03-09T22:22:12Z</dcterms:created>
  <dcterms:modified xsi:type="dcterms:W3CDTF">2023-11-08T03:25:53Z</dcterms:modified>
</cp:coreProperties>
</file>